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7" r:id="rId2"/>
    <p:sldId id="260" r:id="rId3"/>
    <p:sldId id="261" r:id="rId4"/>
    <p:sldId id="262" r:id="rId5"/>
    <p:sldId id="263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608" autoAdjust="0"/>
    <p:restoredTop sz="87959" autoAdjust="0"/>
  </p:normalViewPr>
  <p:slideViewPr>
    <p:cSldViewPr snapToGrid="0">
      <p:cViewPr varScale="1">
        <p:scale>
          <a:sx n="75" d="100"/>
          <a:sy n="75" d="100"/>
        </p:scale>
        <p:origin x="15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02DB39-2856-4335-9FCA-161E02BC8673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673CCC-7676-4F3A-9976-66199FB620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9897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673CCC-7676-4F3A-9976-66199FB620B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85182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673CCC-7676-4F3A-9976-66199FB620B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307444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673CCC-7676-4F3A-9976-66199FB620B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954705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396A26A-03BE-5694-03E8-73FAB530179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706F1B73-83F4-89B6-6104-EA441607B1A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A8868CD5-202A-E51C-78C3-A5623D50D7E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22EDEDD-55A5-E1A5-C035-B75DD77EA8D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673CCC-7676-4F3A-9976-66199FB620B4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55191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6DD1DED-4761-E4C7-DB38-CF7046517B6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8DBAE056-3F8E-6037-D803-8E8E63E53AE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417DC1A8-46CF-1AE5-8B24-81B12D8A8105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0679CD7-E51B-8495-EB2F-81027B6E897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673CCC-7676-4F3A-9976-66199FB620B4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4975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B5C1BA-2EDF-5823-4152-A6555DD3073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D9EDB3A-2327-15A0-0EF6-B2441F13413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E5CC30-C41A-5568-2BE4-1B60B3ACD8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AAA9B-896C-4F32-A449-B4C6F080DA64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CD7BCB-2EC9-A050-87A5-F32C8FEE62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F5F852-8210-707C-D629-40F431CD8E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6DFA5-77E3-4170-B7B5-B5A59BEE0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485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48028D-345D-02A4-C162-3931AC6FF8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9EC2AF-4F43-93F4-C11A-309D64EE08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1A0E1C-6BD4-CABC-0B9B-8314A32365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AAA9B-896C-4F32-A449-B4C6F080DA64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3E6A8F-555D-6505-1B8C-E5963EF466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DB3E55-923A-53EB-DD4F-740A03F500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6DFA5-77E3-4170-B7B5-B5A59BEE0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8404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6F5C0DC-EDD8-442C-1BC2-73FA48BC33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C5B218-8DB6-E03B-A739-2A98E9CF86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4E5AB2-3534-12A7-CDEE-D61B832DF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AAA9B-896C-4F32-A449-B4C6F080DA64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6D785B-E81D-2015-42A3-D2A9D5ADC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36E88F-2389-2194-9CE8-973651B238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6DFA5-77E3-4170-B7B5-B5A59BEE0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72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F46244-850C-42D6-0A8C-B1BBCBDC0A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1B68F8-21C1-A4D6-66A4-8A0A986184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8B08E8-D2FF-EDBA-5381-057D548827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AAA9B-896C-4F32-A449-B4C6F080DA64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E0D0A1-8DCE-BB09-AEE3-52BC9A3396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BB2D13-E280-4207-43E1-CBBA5F716D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6DFA5-77E3-4170-B7B5-B5A59BEE0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5889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A43E8B-8DEF-CDD5-E56A-464EE77C13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7A700F-FE5B-D494-6387-DDF248057A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41741B-29E0-910F-A0F4-625403BF8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AAA9B-896C-4F32-A449-B4C6F080DA64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6CAF81-72D9-FE4A-A420-4CC219E659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A4B452-EBA8-37B2-6E0B-BE2D94D40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6DFA5-77E3-4170-B7B5-B5A59BEE0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4005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378A93-F67F-F683-B05C-783BF1F393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837707-6C2D-7144-1F5E-7872294EAB1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E02F71-403A-7F32-BBA6-A7174FF0D6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3B5F21-9A8A-8575-C9CD-5C7D00AC7F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AAA9B-896C-4F32-A449-B4C6F080DA64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A33C39-79A0-D967-7ED0-B92099726D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7C2AB-DB7E-5079-D8D9-41771D2147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6DFA5-77E3-4170-B7B5-B5A59BEE0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400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3CC49D-AEFE-8EDE-7700-21BC3032E6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F29194-8967-B9AB-30F9-C2B3289924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2A028D-D86C-0C07-308B-B7FE460C0D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00A5EBD-F309-8338-BEEB-FC2CFE1FFCA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FC7F183-DB92-D15B-E2C0-32CE039571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FA6A5C3-D2D6-F57C-8939-85A3AA34C2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AAA9B-896C-4F32-A449-B4C6F080DA64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C1EF499-D247-E760-E25B-B2CE77E1A4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000A903-8701-4B2C-308F-EA1B6E84FF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6DFA5-77E3-4170-B7B5-B5A59BEE0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5645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CDEFBE-7E89-6BA6-A4E2-5F20FE6FF5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C3F2E64-CE1E-F5B5-1C51-F6D7853CA8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AAA9B-896C-4F32-A449-B4C6F080DA64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3444103-05F9-5C5E-C291-3B00D30C98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D865227-79C9-7DAA-2061-59ABB0D64B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6DFA5-77E3-4170-B7B5-B5A59BEE0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6449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08F8D70-CD10-2571-99ED-3E4D871BC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AAA9B-896C-4F32-A449-B4C6F080DA64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03EA566-8EBB-AE01-958D-C52F28EEE4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39471B-E3C8-956F-50CB-D2C9A65FA3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6DFA5-77E3-4170-B7B5-B5A59BEE0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8796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F42062-23E1-A3C3-1A1B-A84F316D2F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29CF44-FEF8-DB71-6BCE-47B744752E1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4701ED-F2E7-A535-B776-0FA1193B90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A4D623-5BCE-52DD-491A-BBA44B52FB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AAA9B-896C-4F32-A449-B4C6F080DA64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E07445-1504-BC46-77D9-2B294C5F05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FD7249-580A-45A7-2836-13B0CFBA2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6DFA5-77E3-4170-B7B5-B5A59BEE0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868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8ED5B1-E1CB-AFDB-5BFF-8FADEC838F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4099531-4B47-DD93-9118-B7E96B1E5D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94D9C3E-DBE5-50E4-1536-8F8F722EDE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AE7C36-B453-C6B6-9EB0-3CD7EC398E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DAAA9B-896C-4F32-A449-B4C6F080DA64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37D713-261E-B12A-007C-1CDA1180C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22216C-54FC-92E3-7BD2-C1EFD58DC8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6DFA5-77E3-4170-B7B5-B5A59BEE0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5559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B662454-5264-EA53-E795-5AFDCF66F9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871AA7-AEF8-E84B-CFA4-9690D5FBF7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D4D017-D3AA-2BDF-5293-E6D0E3971E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6DAAA9B-896C-4F32-A449-B4C6F080DA64}" type="datetimeFigureOut">
              <a:rPr lang="en-US" smtClean="0"/>
              <a:t>2/2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41CE49-5CBD-6BC1-39AB-FBE71B87410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95A4BF-279A-C8EC-F6C3-2AE6D18DB79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026DFA5-77E3-4170-B7B5-B5A59BEE0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529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C546FD6-1B5A-3418-1DC1-65B90CE4955E}"/>
              </a:ext>
            </a:extLst>
          </p:cNvPr>
          <p:cNvSpPr txBox="1"/>
          <p:nvPr/>
        </p:nvSpPr>
        <p:spPr>
          <a:xfrm>
            <a:off x="41588" y="1252968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726EE70-C52F-0F8D-8E47-8C609E6059D8}"/>
              </a:ext>
            </a:extLst>
          </p:cNvPr>
          <p:cNvSpPr txBox="1"/>
          <p:nvPr/>
        </p:nvSpPr>
        <p:spPr>
          <a:xfrm>
            <a:off x="2148252" y="1289541"/>
            <a:ext cx="19409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CRC254 First Study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A348554-2454-0AF2-2A4F-D81BD0A47074}"/>
              </a:ext>
            </a:extLst>
          </p:cNvPr>
          <p:cNvSpPr txBox="1"/>
          <p:nvPr/>
        </p:nvSpPr>
        <p:spPr>
          <a:xfrm>
            <a:off x="8631516" y="1289541"/>
            <a:ext cx="22245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CRC254 Second Study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09893EE-CCE9-F97C-25AA-7ED6207700C9}"/>
              </a:ext>
            </a:extLst>
          </p:cNvPr>
          <p:cNvSpPr txBox="1"/>
          <p:nvPr/>
        </p:nvSpPr>
        <p:spPr>
          <a:xfrm>
            <a:off x="6521646" y="1289541"/>
            <a:ext cx="391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)</a:t>
            </a: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082E6C4F-F8E2-CFE6-C13E-C7BF234F89C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7374204"/>
              </p:ext>
            </p:extLst>
          </p:nvPr>
        </p:nvGraphicFramePr>
        <p:xfrm>
          <a:off x="-125217" y="2139395"/>
          <a:ext cx="6104777" cy="42035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6647025" imgH="4576838" progId="Prism10.Document">
                  <p:embed/>
                </p:oleObj>
              </mc:Choice>
              <mc:Fallback>
                <p:oleObj name="Prism 10" r:id="rId3" imgW="6647025" imgH="4576838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-125217" y="2139395"/>
                        <a:ext cx="6104777" cy="42035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A9769235-F7B6-2C6B-2FC3-271C71AB051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5443489"/>
              </p:ext>
            </p:extLst>
          </p:nvPr>
        </p:nvGraphicFramePr>
        <p:xfrm>
          <a:off x="6295809" y="1890030"/>
          <a:ext cx="6104777" cy="44484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6647025" imgH="4843712" progId="Prism10.Document">
                  <p:embed/>
                </p:oleObj>
              </mc:Choice>
              <mc:Fallback>
                <p:oleObj name="Prism 10" r:id="rId5" imgW="6647025" imgH="4843712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295809" y="1890030"/>
                        <a:ext cx="6104777" cy="44484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99763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0C310B7-3E81-CD8D-02C3-759E59FF2E5F}"/>
              </a:ext>
            </a:extLst>
          </p:cNvPr>
          <p:cNvSpPr txBox="1"/>
          <p:nvPr/>
        </p:nvSpPr>
        <p:spPr>
          <a:xfrm>
            <a:off x="-86116" y="862262"/>
            <a:ext cx="412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A5F1CB7-CC6B-AF23-1D9E-DE8186F8A374}"/>
              </a:ext>
            </a:extLst>
          </p:cNvPr>
          <p:cNvSpPr txBox="1"/>
          <p:nvPr/>
        </p:nvSpPr>
        <p:spPr>
          <a:xfrm>
            <a:off x="1909551" y="862262"/>
            <a:ext cx="19409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CRC254 First Study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081FEDF-1B71-873C-F0B9-719595BCF792}"/>
              </a:ext>
            </a:extLst>
          </p:cNvPr>
          <p:cNvSpPr txBox="1"/>
          <p:nvPr/>
        </p:nvSpPr>
        <p:spPr>
          <a:xfrm>
            <a:off x="8131804" y="871231"/>
            <a:ext cx="22245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CRC254 Second Study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11EECCB-2C47-95AD-703D-0D79B665A020}"/>
              </a:ext>
            </a:extLst>
          </p:cNvPr>
          <p:cNvSpPr txBox="1"/>
          <p:nvPr/>
        </p:nvSpPr>
        <p:spPr>
          <a:xfrm>
            <a:off x="6782014" y="862262"/>
            <a:ext cx="4106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)</a:t>
            </a:r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F973F766-5D1C-E5DC-5375-0D47D569BD3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2782431"/>
              </p:ext>
            </p:extLst>
          </p:nvPr>
        </p:nvGraphicFramePr>
        <p:xfrm>
          <a:off x="6301480" y="1457450"/>
          <a:ext cx="6089904" cy="4752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8713123" imgH="6801509" progId="Prism10.Document">
                  <p:embed/>
                </p:oleObj>
              </mc:Choice>
              <mc:Fallback>
                <p:oleObj name="Prism 10" r:id="rId3" imgW="8713123" imgH="680150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301480" y="1457450"/>
                        <a:ext cx="6089904" cy="4752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7D049112-01A2-E206-521F-3F17A9B14E4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09389379"/>
              </p:ext>
            </p:extLst>
          </p:nvPr>
        </p:nvGraphicFramePr>
        <p:xfrm>
          <a:off x="-82196" y="1457450"/>
          <a:ext cx="6089904" cy="47407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8713123" imgH="6783141" progId="Prism10.Document">
                  <p:embed/>
                </p:oleObj>
              </mc:Choice>
              <mc:Fallback>
                <p:oleObj name="Prism 10" r:id="rId5" imgW="8713123" imgH="6783141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-82196" y="1457450"/>
                        <a:ext cx="6089904" cy="47407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97745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89A8E69-6F56-58FB-98A8-6B5F62775ECA}"/>
              </a:ext>
            </a:extLst>
          </p:cNvPr>
          <p:cNvSpPr txBox="1"/>
          <p:nvPr/>
        </p:nvSpPr>
        <p:spPr>
          <a:xfrm>
            <a:off x="-86116" y="862262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23F2DBA-AB9E-414F-D907-48A1DEB93180}"/>
              </a:ext>
            </a:extLst>
          </p:cNvPr>
          <p:cNvSpPr txBox="1"/>
          <p:nvPr/>
        </p:nvSpPr>
        <p:spPr>
          <a:xfrm>
            <a:off x="2345753" y="862262"/>
            <a:ext cx="18871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CRC254 first study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9CCADE1-237A-2DA1-DC24-572B2B55FB0F}"/>
              </a:ext>
            </a:extLst>
          </p:cNvPr>
          <p:cNvSpPr txBox="1"/>
          <p:nvPr/>
        </p:nvSpPr>
        <p:spPr>
          <a:xfrm>
            <a:off x="5538264" y="862262"/>
            <a:ext cx="373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1EE7E63-50F1-C543-AB42-8BCAAD9E413E}"/>
              </a:ext>
            </a:extLst>
          </p:cNvPr>
          <p:cNvSpPr txBox="1"/>
          <p:nvPr/>
        </p:nvSpPr>
        <p:spPr>
          <a:xfrm>
            <a:off x="7970133" y="862262"/>
            <a:ext cx="18871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CRC254 first study</a:t>
            </a:r>
          </a:p>
        </p:txBody>
      </p:sp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3FBD1F02-1E92-032D-4C37-709325D740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5625688"/>
              </p:ext>
            </p:extLst>
          </p:nvPr>
        </p:nvGraphicFramePr>
        <p:xfrm>
          <a:off x="5712923" y="1744960"/>
          <a:ext cx="6436327" cy="47548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7200553" imgH="5319475" progId="Prism10.Document">
                  <p:embed/>
                </p:oleObj>
              </mc:Choice>
              <mc:Fallback>
                <p:oleObj name="Prism 10" r:id="rId3" imgW="7200553" imgH="531947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712923" y="1744960"/>
                        <a:ext cx="6436327" cy="47548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C78AD107-2DCF-EB86-1EE0-1AF608BF59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2829228"/>
              </p:ext>
            </p:extLst>
          </p:nvPr>
        </p:nvGraphicFramePr>
        <p:xfrm>
          <a:off x="1" y="1629739"/>
          <a:ext cx="5675753" cy="47548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6584721" imgH="5516119" progId="Prism10.Document">
                  <p:embed/>
                </p:oleObj>
              </mc:Choice>
              <mc:Fallback>
                <p:oleObj name="Prism 10" r:id="rId5" imgW="6584721" imgH="551611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" y="1629739"/>
                        <a:ext cx="5675753" cy="47548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254312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61EB3F5-1E4F-35F6-E167-1235A8703C7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CBD8871-1401-9C41-16AF-51652DCEED11}"/>
              </a:ext>
            </a:extLst>
          </p:cNvPr>
          <p:cNvSpPr txBox="1"/>
          <p:nvPr/>
        </p:nvSpPr>
        <p:spPr>
          <a:xfrm>
            <a:off x="-86116" y="862262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032D529-0CAD-DF7F-56CC-979016B0A46A}"/>
              </a:ext>
            </a:extLst>
          </p:cNvPr>
          <p:cNvSpPr txBox="1"/>
          <p:nvPr/>
        </p:nvSpPr>
        <p:spPr>
          <a:xfrm>
            <a:off x="5538264" y="862262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)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80EC7A4-8EE0-208A-8310-B6579CA11D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86116" y="1852758"/>
            <a:ext cx="5747187" cy="397438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17C55A8-146A-F05B-B2B9-D5AF2D32C64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21914" y="1380827"/>
            <a:ext cx="6756503" cy="49726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20548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D395DCC-43E6-2C88-1520-2FB7AD93AF3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899A89DB-0B4B-9737-000B-1A0942E24110}"/>
              </a:ext>
            </a:extLst>
          </p:cNvPr>
          <p:cNvSpPr txBox="1"/>
          <p:nvPr/>
        </p:nvSpPr>
        <p:spPr>
          <a:xfrm>
            <a:off x="-86116" y="862262"/>
            <a:ext cx="311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714A258-919E-9013-4347-FB8EC76EDCF6}"/>
              </a:ext>
            </a:extLst>
          </p:cNvPr>
          <p:cNvSpPr txBox="1"/>
          <p:nvPr/>
        </p:nvSpPr>
        <p:spPr>
          <a:xfrm>
            <a:off x="5538264" y="862262"/>
            <a:ext cx="328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J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F7AB1AC-5771-8786-5611-28A768FE6BE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86116" y="1658662"/>
            <a:ext cx="5808999" cy="410757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CA32232-164C-1AC6-6A6D-200B4134346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51730" y="1268884"/>
            <a:ext cx="6640270" cy="48871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26550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90</TotalTime>
  <Words>43</Words>
  <Application>Microsoft Office PowerPoint</Application>
  <PresentationFormat>Widescreen</PresentationFormat>
  <Paragraphs>21</Paragraphs>
  <Slides>5</Slides>
  <Notes>5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ptos</vt:lpstr>
      <vt:lpstr>Aptos Display</vt:lpstr>
      <vt:lpstr>Arial</vt:lpstr>
      <vt:lpstr>Calibri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ominguez, Adrian</dc:creator>
  <cp:lastModifiedBy>Dominguez, Adrian</cp:lastModifiedBy>
  <cp:revision>55</cp:revision>
  <dcterms:created xsi:type="dcterms:W3CDTF">2024-10-23T20:29:44Z</dcterms:created>
  <dcterms:modified xsi:type="dcterms:W3CDTF">2026-02-24T17:32:01Z</dcterms:modified>
</cp:coreProperties>
</file>